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408738" cy="7019925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0F69C-EF38-470A-82B7-DD1D28375A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20760" y="1638360"/>
            <a:ext cx="576720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20760" y="4058640"/>
            <a:ext cx="576720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A90A8-E369-409B-845E-52454981A3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20760" y="1638360"/>
            <a:ext cx="281412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76000" y="1638360"/>
            <a:ext cx="281412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20760" y="4058640"/>
            <a:ext cx="281412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76000" y="4058640"/>
            <a:ext cx="281412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D3F43-B97C-49EC-8C6A-B7AF3CD2E1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20760" y="1638360"/>
            <a:ext cx="185688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70880" y="1638360"/>
            <a:ext cx="185688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221000" y="1638360"/>
            <a:ext cx="185688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20760" y="4058640"/>
            <a:ext cx="185688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70880" y="4058640"/>
            <a:ext cx="185688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221000" y="4058640"/>
            <a:ext cx="185688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5BEC4-E83F-44A3-9900-9C8DD4539B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20760" y="1638360"/>
            <a:ext cx="5767200" cy="4633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75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C86E91-570B-487A-8D04-E003E5EC29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20760" y="1638360"/>
            <a:ext cx="5767200" cy="46339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426E19-3EB6-4716-8429-A7BE3850BD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20760" y="1638360"/>
            <a:ext cx="2814120" cy="46339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76000" y="1638360"/>
            <a:ext cx="2814120" cy="46339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87FD79-AA06-4233-8B16-CDE0474265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266DB-40E9-417A-8820-D177410FC5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20760" y="281160"/>
            <a:ext cx="5767200" cy="543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3A7D2-7732-4BCD-A280-020FC017EE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20760" y="1638360"/>
            <a:ext cx="281412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76000" y="1638360"/>
            <a:ext cx="2814120" cy="46339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20760" y="4058640"/>
            <a:ext cx="281412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30940-2C89-401A-BD9A-B7A2E95443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20760" y="1638360"/>
            <a:ext cx="2814120" cy="46339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76000" y="1638360"/>
            <a:ext cx="281412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76000" y="4058640"/>
            <a:ext cx="281412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A37DF-D0F2-405E-9EF8-B823372F27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20760" y="1638360"/>
            <a:ext cx="281412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76000" y="1638360"/>
            <a:ext cx="281412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20760" y="4058640"/>
            <a:ext cx="5767200" cy="2210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675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F4D3C-DF9E-444D-BFB7-11A55376CF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20760" y="281160"/>
            <a:ext cx="5767200" cy="11714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20760" y="1638360"/>
            <a:ext cx="5767200" cy="46339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marL="295200" indent="-295200">
              <a:spcBef>
                <a:spcPts val="675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1" marL="639720" indent="-245880">
              <a:spcBef>
                <a:spcPts val="675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2" marL="984240" indent="-196920">
              <a:spcBef>
                <a:spcPts val="675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3" marL="1378080" indent="-196920">
              <a:spcBef>
                <a:spcPts val="675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4" marL="1771560" indent="-196920">
              <a:spcBef>
                <a:spcPts val="675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5" marL="1771560" indent="-196920">
              <a:spcBef>
                <a:spcPts val="675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  <a:p>
            <a:pPr lvl="6" marL="1771560" indent="-196920">
              <a:spcBef>
                <a:spcPts val="675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20760" y="6508800"/>
            <a:ext cx="1495440" cy="3729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1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89160" y="6508800"/>
            <a:ext cx="2030400" cy="3729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92520" y="6508800"/>
            <a:ext cx="1495440" cy="3729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F2AFB4-A2E9-43F5-9F9D-DAB1F54F27A7}" type="slidenum">
              <a:rPr b="0" lang="es-MX" sz="11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10 Gráfico" descr=""/>
          <p:cNvPicPr/>
          <p:nvPr/>
        </p:nvPicPr>
        <p:blipFill>
          <a:blip r:embed="rId1"/>
          <a:stretch/>
        </p:blipFill>
        <p:spPr>
          <a:xfrm>
            <a:off x="1505053080" y="1648987200"/>
            <a:ext cx="12960" cy="10800"/>
          </a:xfrm>
          <a:prstGeom prst="rect">
            <a:avLst/>
          </a:prstGeom>
          <a:ln w="0">
            <a:noFill/>
          </a:ln>
        </p:spPr>
      </p:pic>
      <p:pic>
        <p:nvPicPr>
          <p:cNvPr id="42" name="11 Gráfico" descr=""/>
          <p:cNvPicPr/>
          <p:nvPr/>
        </p:nvPicPr>
        <p:blipFill>
          <a:blip r:embed="rId2"/>
          <a:stretch/>
        </p:blipFill>
        <p:spPr>
          <a:xfrm>
            <a:off x="-49320" y="1648987200"/>
            <a:ext cx="12960" cy="10800"/>
          </a:xfrm>
          <a:prstGeom prst="rect">
            <a:avLst/>
          </a:prstGeom>
          <a:ln w="0">
            <a:noFill/>
          </a:ln>
        </p:spPr>
      </p:pic>
      <p:pic>
        <p:nvPicPr>
          <p:cNvPr id="43" name="13 Gráfico" descr=""/>
          <p:cNvPicPr/>
          <p:nvPr/>
        </p:nvPicPr>
        <p:blipFill>
          <a:blip r:embed="rId3"/>
          <a:stretch/>
        </p:blipFill>
        <p:spPr>
          <a:xfrm>
            <a:off x="1505053080" y="1648987200"/>
            <a:ext cx="12960" cy="10800"/>
          </a:xfrm>
          <a:prstGeom prst="rect">
            <a:avLst/>
          </a:prstGeom>
          <a:ln w="0">
            <a:noFill/>
          </a:ln>
        </p:spPr>
      </p:pic>
      <p:pic>
        <p:nvPicPr>
          <p:cNvPr id="44" name="14 Gráfico" descr=""/>
          <p:cNvPicPr/>
          <p:nvPr/>
        </p:nvPicPr>
        <p:blipFill>
          <a:blip r:embed="rId4"/>
          <a:stretch/>
        </p:blipFill>
        <p:spPr>
          <a:xfrm>
            <a:off x="1505053080" y="1648987200"/>
            <a:ext cx="12960" cy="10800"/>
          </a:xfrm>
          <a:prstGeom prst="rect">
            <a:avLst/>
          </a:prstGeom>
          <a:ln w="0">
            <a:noFill/>
          </a:ln>
        </p:spPr>
      </p:pic>
      <p:pic>
        <p:nvPicPr>
          <p:cNvPr id="45" name="2 Gráfico" descr=""/>
          <p:cNvPicPr/>
          <p:nvPr/>
        </p:nvPicPr>
        <p:blipFill>
          <a:blip r:embed="rId5"/>
          <a:stretch/>
        </p:blipFill>
        <p:spPr>
          <a:xfrm>
            <a:off x="122400" y="-73080"/>
            <a:ext cx="3090600" cy="3413160"/>
          </a:xfrm>
          <a:prstGeom prst="rect">
            <a:avLst/>
          </a:prstGeom>
          <a:ln w="0">
            <a:noFill/>
          </a:ln>
        </p:spPr>
      </p:pic>
      <p:pic>
        <p:nvPicPr>
          <p:cNvPr id="46" name="3 Gráfico" descr=""/>
          <p:cNvPicPr/>
          <p:nvPr/>
        </p:nvPicPr>
        <p:blipFill>
          <a:blip r:embed="rId6"/>
          <a:stretch/>
        </p:blipFill>
        <p:spPr>
          <a:xfrm>
            <a:off x="3200400" y="-96840"/>
            <a:ext cx="3108240" cy="3443400"/>
          </a:xfrm>
          <a:prstGeom prst="rect">
            <a:avLst/>
          </a:prstGeom>
          <a:ln w="0">
            <a:noFill/>
          </a:ln>
        </p:spPr>
      </p:pic>
      <p:grpSp>
        <p:nvGrpSpPr>
          <p:cNvPr id="47" name="184 Grupo"/>
          <p:cNvGrpSpPr/>
          <p:nvPr/>
        </p:nvGrpSpPr>
        <p:grpSpPr>
          <a:xfrm>
            <a:off x="108000" y="6391440"/>
            <a:ext cx="6359400" cy="502920"/>
            <a:chOff x="108000" y="6391440"/>
            <a:chExt cx="6359400" cy="502920"/>
          </a:xfrm>
        </p:grpSpPr>
        <p:grpSp>
          <p:nvGrpSpPr>
            <p:cNvPr id="48" name="32 Grupo"/>
            <p:cNvGrpSpPr/>
            <p:nvPr/>
          </p:nvGrpSpPr>
          <p:grpSpPr>
            <a:xfrm>
              <a:off x="108000" y="6391440"/>
              <a:ext cx="6192720" cy="502920"/>
              <a:chOff x="108000" y="6391440"/>
              <a:chExt cx="6192720" cy="502920"/>
            </a:xfrm>
          </p:grpSpPr>
          <p:sp>
            <p:nvSpPr>
              <p:cNvPr id="49" name="191 Rectángulo"/>
              <p:cNvSpPr/>
              <p:nvPr/>
            </p:nvSpPr>
            <p:spPr>
              <a:xfrm>
                <a:off x="108000" y="6391440"/>
                <a:ext cx="6192720" cy="502920"/>
              </a:xfrm>
              <a:prstGeom prst="rect">
                <a:avLst/>
              </a:prstGeom>
              <a:solidFill>
                <a:srgbClr val="ffffff"/>
              </a:solidFill>
              <a:ln cap="rnd" w="6480">
                <a:solidFill>
                  <a:srgbClr val="000000"/>
                </a:solidFill>
                <a:custDash>
                  <a:ds d="499000" sp="20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192 Conector recto"/>
              <p:cNvSpPr/>
              <p:nvPr/>
            </p:nvSpPr>
            <p:spPr>
              <a:xfrm>
                <a:off x="179280" y="6558120"/>
                <a:ext cx="493560" cy="0"/>
              </a:xfrm>
              <a:prstGeom prst="line">
                <a:avLst/>
              </a:prstGeom>
              <a:ln w="2844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193 Conector recto"/>
              <p:cNvSpPr/>
              <p:nvPr/>
            </p:nvSpPr>
            <p:spPr>
              <a:xfrm>
                <a:off x="179280" y="6721560"/>
                <a:ext cx="493560" cy="0"/>
              </a:xfrm>
              <a:prstGeom prst="line">
                <a:avLst/>
              </a:prstGeom>
              <a:ln w="28440">
                <a:solidFill>
                  <a:srgbClr val="8064a2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194 Conector recto"/>
              <p:cNvSpPr/>
              <p:nvPr/>
            </p:nvSpPr>
            <p:spPr>
              <a:xfrm>
                <a:off x="2417760" y="6558120"/>
                <a:ext cx="495000" cy="0"/>
              </a:xfrm>
              <a:prstGeom prst="line">
                <a:avLst/>
              </a:prstGeom>
              <a:ln w="2844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195 Conector recto"/>
              <p:cNvSpPr/>
              <p:nvPr/>
            </p:nvSpPr>
            <p:spPr>
              <a:xfrm>
                <a:off x="4788000" y="6558120"/>
                <a:ext cx="495000" cy="0"/>
              </a:xfrm>
              <a:prstGeom prst="line">
                <a:avLst/>
              </a:prstGeom>
              <a:ln w="28440">
                <a:solidFill>
                  <a:srgbClr val="9bbb5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196 Conector recto"/>
              <p:cNvSpPr/>
              <p:nvPr/>
            </p:nvSpPr>
            <p:spPr>
              <a:xfrm>
                <a:off x="2417760" y="6721560"/>
                <a:ext cx="495000" cy="0"/>
              </a:xfrm>
              <a:prstGeom prst="line">
                <a:avLst/>
              </a:prstGeom>
              <a:ln w="28440">
                <a:solidFill>
                  <a:srgbClr val="4bacc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5" name="29 CuadroTexto"/>
            <p:cNvSpPr/>
            <p:nvPr/>
          </p:nvSpPr>
          <p:spPr>
            <a:xfrm>
              <a:off x="612000" y="6607440"/>
              <a:ext cx="223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Arial"/>
                </a:rPr>
                <a:t>Has initiated sexual activit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22 CuadroTexto"/>
            <p:cNvSpPr/>
            <p:nvPr/>
          </p:nvSpPr>
          <p:spPr>
            <a:xfrm>
              <a:off x="612000" y="6432840"/>
              <a:ext cx="154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Arial"/>
                </a:rPr>
                <a:t>Ever smok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30 CuadroTexto"/>
            <p:cNvSpPr/>
            <p:nvPr/>
          </p:nvSpPr>
          <p:spPr>
            <a:xfrm>
              <a:off x="2832840" y="6607440"/>
              <a:ext cx="317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Arial"/>
                </a:rPr>
                <a:t>Condom use at last sexual encount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23 CuadroTexto"/>
            <p:cNvSpPr/>
            <p:nvPr/>
          </p:nvSpPr>
          <p:spPr>
            <a:xfrm>
              <a:off x="2844360" y="6432840"/>
              <a:ext cx="194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Arial"/>
                </a:rPr>
                <a:t>Smokes currentl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28 CuadroTexto"/>
            <p:cNvSpPr/>
            <p:nvPr/>
          </p:nvSpPr>
          <p:spPr>
            <a:xfrm>
              <a:off x="5221080" y="6432840"/>
              <a:ext cx="1246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1000" spc="-1" strike="noStrike">
                  <a:solidFill>
                    <a:srgbClr val="000000"/>
                  </a:solidFill>
                  <a:latin typeface="Arial"/>
                </a:rPr>
                <a:t>Drinks alcoho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0" name="4 Gráfico" descr=""/>
          <p:cNvPicPr/>
          <p:nvPr/>
        </p:nvPicPr>
        <p:blipFill>
          <a:blip r:embed="rId7"/>
          <a:stretch/>
        </p:blipFill>
        <p:spPr>
          <a:xfrm>
            <a:off x="103320" y="3071880"/>
            <a:ext cx="3109680" cy="3468600"/>
          </a:xfrm>
          <a:prstGeom prst="rect">
            <a:avLst/>
          </a:prstGeom>
          <a:ln w="0">
            <a:noFill/>
          </a:ln>
        </p:spPr>
      </p:pic>
      <p:pic>
        <p:nvPicPr>
          <p:cNvPr id="61" name="5 Gráfico" descr=""/>
          <p:cNvPicPr/>
          <p:nvPr/>
        </p:nvPicPr>
        <p:blipFill>
          <a:blip r:embed="rId8"/>
          <a:stretch/>
        </p:blipFill>
        <p:spPr>
          <a:xfrm>
            <a:off x="3200400" y="3071880"/>
            <a:ext cx="3114720" cy="3468600"/>
          </a:xfrm>
          <a:prstGeom prst="rect">
            <a:avLst/>
          </a:prstGeom>
          <a:ln w="0">
            <a:noFill/>
          </a:ln>
        </p:spPr>
      </p:pic>
      <p:sp>
        <p:nvSpPr>
          <p:cNvPr id="62" name="199 Rectángulo"/>
          <p:cNvSpPr/>
          <p:nvPr/>
        </p:nvSpPr>
        <p:spPr>
          <a:xfrm>
            <a:off x="1189080" y="2790720"/>
            <a:ext cx="1152360" cy="289080"/>
          </a:xfrm>
          <a:prstGeom prst="rect">
            <a:avLst/>
          </a:prstGeom>
          <a:solidFill>
            <a:srgbClr val="dce6f2">
              <a:alpha val="5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200 Rectángulo"/>
          <p:cNvSpPr/>
          <p:nvPr/>
        </p:nvSpPr>
        <p:spPr>
          <a:xfrm>
            <a:off x="4267080" y="2790720"/>
            <a:ext cx="1170000" cy="289080"/>
          </a:xfrm>
          <a:prstGeom prst="rect">
            <a:avLst/>
          </a:prstGeom>
          <a:solidFill>
            <a:srgbClr val="dce6f2">
              <a:alpha val="5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201 Rectángulo"/>
          <p:cNvSpPr/>
          <p:nvPr/>
        </p:nvSpPr>
        <p:spPr>
          <a:xfrm>
            <a:off x="1117440" y="5961240"/>
            <a:ext cx="1150920" cy="287280"/>
          </a:xfrm>
          <a:prstGeom prst="rect">
            <a:avLst/>
          </a:prstGeom>
          <a:solidFill>
            <a:srgbClr val="dce6f2">
              <a:alpha val="5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202 Rectángulo"/>
          <p:cNvSpPr/>
          <p:nvPr/>
        </p:nvSpPr>
        <p:spPr>
          <a:xfrm>
            <a:off x="4284720" y="5961240"/>
            <a:ext cx="1152360" cy="287280"/>
          </a:xfrm>
          <a:prstGeom prst="rect">
            <a:avLst/>
          </a:prstGeom>
          <a:solidFill>
            <a:srgbClr val="dce6f2">
              <a:alpha val="5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03T14:35:25Z</dcterms:created>
  <dc:creator>AtienzoE</dc:creator>
  <dc:description/>
  <dc:language>en-US</dc:language>
  <cp:lastModifiedBy>Erika E Atienzo</cp:lastModifiedBy>
  <dcterms:modified xsi:type="dcterms:W3CDTF">2011-11-11T01:09:31Z</dcterms:modified>
  <cp:revision>63</cp:revision>
  <dc:subject/>
  <dc:title>Diapositiva 1</dc:title>
</cp:coreProperties>
</file>